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975BEC-9A7F-4E6F-87B2-2CE6D1B06BEA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2FC5B0-639B-4431-95E3-CB870F91D0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4922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F6C4BA-CDED-493B-8B56-4F00D6E6B58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5940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CC7F6-FD55-4F77-BCBC-F493491519C1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A169D-3BD1-47A7-8921-8BDB18C96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327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CC7F6-FD55-4F77-BCBC-F493491519C1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A169D-3BD1-47A7-8921-8BDB18C96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941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CC7F6-FD55-4F77-BCBC-F493491519C1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A169D-3BD1-47A7-8921-8BDB18C96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8464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CC7F6-FD55-4F77-BCBC-F493491519C1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A169D-3BD1-47A7-8921-8BDB18C96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336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CC7F6-FD55-4F77-BCBC-F493491519C1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A169D-3BD1-47A7-8921-8BDB18C96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717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CC7F6-FD55-4F77-BCBC-F493491519C1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A169D-3BD1-47A7-8921-8BDB18C96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247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CC7F6-FD55-4F77-BCBC-F493491519C1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A169D-3BD1-47A7-8921-8BDB18C96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13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CC7F6-FD55-4F77-BCBC-F493491519C1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A169D-3BD1-47A7-8921-8BDB18C96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204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CC7F6-FD55-4F77-BCBC-F493491519C1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A169D-3BD1-47A7-8921-8BDB18C96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788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CC7F6-FD55-4F77-BCBC-F493491519C1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A169D-3BD1-47A7-8921-8BDB18C96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631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CC7F6-FD55-4F77-BCBC-F493491519C1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A169D-3BD1-47A7-8921-8BDB18C96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0632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8CC7F6-FD55-4F77-BCBC-F493491519C1}" type="datetimeFigureOut">
              <a:rPr lang="en-US" smtClean="0"/>
              <a:t>3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5A169D-3BD1-47A7-8921-8BDB18C96E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611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3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1.png"/><Relationship Id="rId5" Type="http://schemas.microsoft.com/office/2007/relationships/media" Target="../media/media3.mp4"/><Relationship Id="rId10" Type="http://schemas.openxmlformats.org/officeDocument/2006/relationships/notesSlide" Target="../notesSlides/notesSlide1.xml"/><Relationship Id="rId4" Type="http://schemas.openxmlformats.org/officeDocument/2006/relationships/video" Target="../media/media2.mp4"/><Relationship Id="rId9" Type="http://schemas.openxmlformats.org/officeDocument/2006/relationships/slideLayout" Target="../slideLayouts/slideLayout2.xml"/><Relationship Id="rId1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36077" y="1913669"/>
            <a:ext cx="10064262" cy="4434375"/>
          </a:xfrm>
        </p:spPr>
        <p:txBody>
          <a:bodyPr>
            <a:normAutofit/>
          </a:bodyPr>
          <a:lstStyle/>
          <a:p>
            <a:pPr algn="l"/>
            <a:r>
              <a:rPr lang="en-US" sz="4000" dirty="0"/>
              <a:t>Video 2. Transthoracic echocardiogram (TTE) color Doppler imaging: </a:t>
            </a:r>
            <a:br>
              <a:rPr lang="en-US" sz="4000" dirty="0"/>
            </a:br>
            <a:r>
              <a:rPr lang="en-US" sz="4000" dirty="0"/>
              <a:t>A. PLAX view, </a:t>
            </a:r>
            <a:br>
              <a:rPr lang="en-US" sz="4000" dirty="0"/>
            </a:br>
            <a:r>
              <a:rPr lang="en-US" sz="4000" dirty="0"/>
              <a:t>B. A3C view, </a:t>
            </a:r>
            <a:br>
              <a:rPr lang="en-US" sz="4000" dirty="0"/>
            </a:br>
            <a:r>
              <a:rPr lang="en-US" sz="4000" dirty="0"/>
              <a:t>C. PSAX view, </a:t>
            </a:r>
            <a:br>
              <a:rPr lang="en-US" sz="4000" dirty="0"/>
            </a:br>
            <a:r>
              <a:rPr lang="en-US" sz="4000" dirty="0"/>
              <a:t>D. A4C view showing intra-valvular leak of the bioprosthetic valve</a:t>
            </a:r>
          </a:p>
        </p:txBody>
      </p:sp>
    </p:spTree>
    <p:extLst>
      <p:ext uri="{BB962C8B-B14F-4D97-AF65-F5344CB8AC3E}">
        <p14:creationId xmlns:p14="http://schemas.microsoft.com/office/powerpoint/2010/main" val="9923543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Regurg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1"/>
          <a:stretch>
            <a:fillRect/>
          </a:stretch>
        </p:blipFill>
        <p:spPr>
          <a:xfrm>
            <a:off x="6144048" y="19050"/>
            <a:ext cx="4547015" cy="3409950"/>
          </a:xfrm>
        </p:spPr>
      </p:pic>
      <p:pic>
        <p:nvPicPr>
          <p:cNvPr id="6" name="CS color 2D PLAX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2"/>
          <a:stretch>
            <a:fillRect/>
          </a:stretch>
        </p:blipFill>
        <p:spPr>
          <a:xfrm>
            <a:off x="1495425" y="0"/>
            <a:ext cx="4597819" cy="3448050"/>
          </a:xfrm>
          <a:prstGeom prst="rect">
            <a:avLst/>
          </a:prstGeom>
        </p:spPr>
      </p:pic>
      <p:pic>
        <p:nvPicPr>
          <p:cNvPr id="7" name="CS color 2D PSAX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3"/>
          <a:stretch>
            <a:fillRect/>
          </a:stretch>
        </p:blipFill>
        <p:spPr>
          <a:xfrm>
            <a:off x="1495425" y="3409950"/>
            <a:ext cx="4597819" cy="3448050"/>
          </a:xfrm>
          <a:prstGeom prst="rect">
            <a:avLst/>
          </a:prstGeom>
        </p:spPr>
      </p:pic>
      <p:pic>
        <p:nvPicPr>
          <p:cNvPr id="8" name="Regurg AC4">
            <a:hlinkClick r:id="" action="ppaction://media"/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4"/>
          <a:stretch>
            <a:fillRect/>
          </a:stretch>
        </p:blipFill>
        <p:spPr>
          <a:xfrm>
            <a:off x="6144047" y="3448050"/>
            <a:ext cx="4547016" cy="3462338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876425" y="2667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637110" y="27463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876425" y="371475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578145" y="370129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19010293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3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>
                <p:cTn id="19" repeatCount="indefinite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20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1" fill="hold">
                      <p:stCondLst>
                        <p:cond delay="0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25" repeatCount="indefinite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7</Words>
  <Application>Microsoft Office PowerPoint</Application>
  <PresentationFormat>Widescreen</PresentationFormat>
  <Paragraphs>6</Paragraphs>
  <Slides>2</Slides>
  <Notes>1</Notes>
  <HiddenSlides>0</HiddenSlides>
  <MMClips>4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Video 2. Transthoracic echocardiogram (TTE) color Doppler imaging:  A. PLAX view,  B. A3C view,  C. PSAX view,  D. A4C view showing intra-valvular leak of the bioprosthetic valv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CHO/CATH/TEE Video clips</dc:title>
  <dc:creator>Shrestha MBBS, Dhan</dc:creator>
  <cp:lastModifiedBy>Shrestha MBBS, Dhan</cp:lastModifiedBy>
  <cp:revision>4</cp:revision>
  <dcterms:created xsi:type="dcterms:W3CDTF">2025-05-19T21:23:28Z</dcterms:created>
  <dcterms:modified xsi:type="dcterms:W3CDTF">2026-03-13T12:54:19Z</dcterms:modified>
</cp:coreProperties>
</file>